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49740B-398B-467F-8B25-554655C2E98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639E89-892B-4E89-8A1B-790B285D865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51579-09E8-4439-8654-F8688D672F7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E21AAB-41FE-4E25-A2E7-7E6EDE06D24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0E0D0E-0EB3-41D6-AF66-D73DECA8AC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92FEEC1-190C-45E6-B1BA-B5DF687E05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5D2514-A011-4AA6-8375-88FAAD8ED0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F7E38-84D4-4322-B8C9-9BEB411FF9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A356D8-C48F-452C-8863-CB9AAFDA989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821671-C805-44D4-92C7-E007D733B0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3B2C74-863D-4F0D-854A-68A92ABF4BE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490651-9A6C-44EB-9276-461486F3A2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l-GR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l-G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DCAA27-A9ED-42FF-9B20-88EA2E93C3AD}" type="slidenum">
              <a:rPr b="0" lang="el-G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28600" y="334800"/>
            <a:ext cx="8534520" cy="3873960"/>
            <a:chOff x="228600" y="334800"/>
            <a:chExt cx="8534520" cy="3873960"/>
          </a:xfrm>
        </p:grpSpPr>
        <p:sp>
          <p:nvSpPr>
            <p:cNvPr id="42" name=""/>
            <p:cNvSpPr/>
            <p:nvPr/>
          </p:nvSpPr>
          <p:spPr>
            <a:xfrm>
              <a:off x="228600" y="334800"/>
              <a:ext cx="8381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Table S1: Fold differences of microRNAs detected by TaqMan microRNA assay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6864480" y="3389400"/>
              <a:ext cx="136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892760" y="3389400"/>
              <a:ext cx="19717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4581360" y="3389400"/>
              <a:ext cx="3114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743200" y="3389400"/>
              <a:ext cx="18381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2,70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838080" y="3389400"/>
              <a:ext cx="190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miR-509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6864480" y="3114720"/>
              <a:ext cx="136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892760" y="3114720"/>
              <a:ext cx="19717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581360" y="3114720"/>
              <a:ext cx="3114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743200" y="3114720"/>
              <a:ext cx="18381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2,73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838080" y="3114720"/>
              <a:ext cx="190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miR-23b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6864480" y="2840040"/>
              <a:ext cx="136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-2,24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892760" y="2840040"/>
              <a:ext cx="19717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miR-373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581360" y="2840040"/>
              <a:ext cx="3114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743200" y="2840040"/>
              <a:ext cx="18381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3,4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838080" y="2840040"/>
              <a:ext cx="190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miR-30b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6864480" y="2565360"/>
              <a:ext cx="136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-2,55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4892760" y="2565360"/>
              <a:ext cx="19717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miR-26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4581360" y="2565360"/>
              <a:ext cx="3114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743200" y="2565360"/>
              <a:ext cx="18381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4,22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838080" y="2565360"/>
              <a:ext cx="190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miR-223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864480" y="2290680"/>
              <a:ext cx="136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-3,38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4892760" y="2290680"/>
              <a:ext cx="19717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miR-210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4581360" y="2290680"/>
              <a:ext cx="3114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743200" y="2290680"/>
              <a:ext cx="18381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4,62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838080" y="2290680"/>
              <a:ext cx="190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miR-</a:t>
              </a: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16</a:t>
              </a:r>
              <a:r>
                <a:rPr b="0" lang="el-GR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6864480" y="2016000"/>
              <a:ext cx="136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-3,57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892760" y="2016000"/>
              <a:ext cx="19717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miR-337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4581360" y="2016000"/>
              <a:ext cx="3114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743200" y="2016000"/>
              <a:ext cx="18381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5,00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838080" y="2016000"/>
              <a:ext cx="190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miR-103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6864480" y="1741320"/>
              <a:ext cx="136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-3,60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4892760" y="1741320"/>
              <a:ext cx="19717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miR-25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4581360" y="1741320"/>
              <a:ext cx="3114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743200" y="1741320"/>
              <a:ext cx="18381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5,20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838080" y="1741320"/>
              <a:ext cx="190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miR-377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6864480" y="1467000"/>
              <a:ext cx="136512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-4,0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4892760" y="1467000"/>
              <a:ext cx="197172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miR-140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4581360" y="1467000"/>
              <a:ext cx="31140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743200" y="1467000"/>
              <a:ext cx="183816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5,78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838080" y="1467000"/>
              <a:ext cx="1905120" cy="274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miR-22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6864480" y="1192320"/>
              <a:ext cx="136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-5,19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892760" y="1192320"/>
              <a:ext cx="19717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miR-29a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581360" y="1192320"/>
              <a:ext cx="3114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743200" y="1192320"/>
              <a:ext cx="18381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10,66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838080" y="1192320"/>
              <a:ext cx="19051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 fontScale="99000"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hsa-</a:t>
              </a:r>
              <a:r>
                <a:rPr b="0" lang="el-GR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miR-48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6864480" y="914400"/>
              <a:ext cx="1365120" cy="277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FOLD CHAN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892760" y="914400"/>
              <a:ext cx="1971720" cy="277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339966"/>
                  </a:solidFill>
                  <a:latin typeface="Arial"/>
                  <a:ea typeface="Arial"/>
                </a:rPr>
                <a:t>DOWN-REGULAT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4581360" y="914400"/>
              <a:ext cx="311400" cy="277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spcBef>
                  <a:spcPts val="300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743200" y="914400"/>
              <a:ext cx="1838160" cy="277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FOLD CHANGE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838080" y="914400"/>
              <a:ext cx="1905120" cy="277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b">
              <a:norm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0000"/>
                  </a:solidFill>
                  <a:latin typeface="Arial"/>
                  <a:ea typeface="Arial"/>
                </a:rPr>
                <a:t>UP-REGULATE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838080" y="914400"/>
              <a:ext cx="7391520" cy="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838080" y="3664080"/>
              <a:ext cx="7391520" cy="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838080" y="914400"/>
              <a:ext cx="0" cy="274968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8229600" y="914400"/>
              <a:ext cx="0" cy="2749680"/>
            </a:xfrm>
            <a:prstGeom prst="line">
              <a:avLst/>
            </a:prstGeom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838080" y="1192320"/>
              <a:ext cx="374328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4892760" y="1192320"/>
              <a:ext cx="3336840" cy="0"/>
            </a:xfrm>
            <a:prstGeom prst="line">
              <a:avLst/>
            </a:prstGeom>
            <a:ln cap="rnd"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038480" y="3962520"/>
              <a:ext cx="4724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microRNAs in this list are &gt;2 fold deregulate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Dimitrios</cp:lastModifiedBy>
  <dcterms:modified xsi:type="dcterms:W3CDTF">2008-10-31T02:29:00Z</dcterms:modified>
  <cp:revision>106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